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17" Type="http://schemas.openxmlformats.org/officeDocument/2006/relationships/image" Target="../media/image17.emf"/><Relationship Id="rId2" Type="http://schemas.openxmlformats.org/officeDocument/2006/relationships/image" Target="../media/image2.emf"/><Relationship Id="rId16" Type="http://schemas.openxmlformats.org/officeDocument/2006/relationships/image" Target="../media/image16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5" Type="http://schemas.openxmlformats.org/officeDocument/2006/relationships/image" Target="../media/image1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575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183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744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877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681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110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92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742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154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080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950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6C17B0-ABC7-49D8-ACAA-789506229064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2EAD13-B1A0-4B74-88D6-11880AE2C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0676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34" Type="http://schemas.openxmlformats.org/officeDocument/2006/relationships/image" Target="../media/image16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33" Type="http://schemas.openxmlformats.org/officeDocument/2006/relationships/oleObject" Target="../embeddings/oleObject16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29" Type="http://schemas.openxmlformats.org/officeDocument/2006/relationships/oleObject" Target="../embeddings/oleObject14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32" Type="http://schemas.openxmlformats.org/officeDocument/2006/relationships/image" Target="../media/image15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3.emf"/><Relationship Id="rId36" Type="http://schemas.openxmlformats.org/officeDocument/2006/relationships/image" Target="../media/image17.emf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31" Type="http://schemas.openxmlformats.org/officeDocument/2006/relationships/oleObject" Target="../embeddings/oleObject15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14.emf"/><Relationship Id="rId35" Type="http://schemas.openxmlformats.org/officeDocument/2006/relationships/oleObject" Target="../embeddings/oleObject17.bin"/><Relationship Id="rId8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1113906" y="266010"/>
            <a:ext cx="9452247" cy="5644339"/>
            <a:chOff x="451339" y="0"/>
            <a:chExt cx="10057896" cy="6593592"/>
          </a:xfrm>
        </p:grpSpPr>
        <p:grpSp>
          <p:nvGrpSpPr>
            <p:cNvPr id="22" name="Group 21"/>
            <p:cNvGrpSpPr/>
            <p:nvPr/>
          </p:nvGrpSpPr>
          <p:grpSpPr>
            <a:xfrm>
              <a:off x="451339" y="0"/>
              <a:ext cx="9804731" cy="2286005"/>
              <a:chOff x="-155488" y="-115113"/>
              <a:chExt cx="9804731" cy="2286005"/>
            </a:xfrm>
          </p:grpSpPr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627684236"/>
                  </p:ext>
                </p:extLst>
              </p:nvPr>
            </p:nvGraphicFramePr>
            <p:xfrm>
              <a:off x="-155488" y="-115108"/>
              <a:ext cx="1920392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3" name="Prism 9" r:id="rId3" imgW="2376896" imgH="2828290" progId="Prism9.Document">
                      <p:embed/>
                    </p:oleObj>
                  </mc:Choice>
                  <mc:Fallback>
                    <p:oleObj name="Prism 9" r:id="rId3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-155488" y="-115108"/>
                            <a:ext cx="1920392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607969439"/>
                  </p:ext>
                </p:extLst>
              </p:nvPr>
            </p:nvGraphicFramePr>
            <p:xfrm>
              <a:off x="1364423" y="-115113"/>
              <a:ext cx="1920392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4" name="Prism 9" r:id="rId5" imgW="2376896" imgH="2828290" progId="Prism9.Document">
                      <p:embed/>
                    </p:oleObj>
                  </mc:Choice>
                  <mc:Fallback>
                    <p:oleObj name="Prism 9" r:id="rId5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1364423" y="-115113"/>
                            <a:ext cx="1920392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Object 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59206448"/>
                  </p:ext>
                </p:extLst>
              </p:nvPr>
            </p:nvGraphicFramePr>
            <p:xfrm>
              <a:off x="2934770" y="-115113"/>
              <a:ext cx="1920392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5" name="Prism 9" r:id="rId7" imgW="2376896" imgH="2828290" progId="Prism9.Document">
                      <p:embed/>
                    </p:oleObj>
                  </mc:Choice>
                  <mc:Fallback>
                    <p:oleObj name="Prism 9" r:id="rId7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2934770" y="-115113"/>
                            <a:ext cx="1920392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7" name="Object 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62281758"/>
                  </p:ext>
                </p:extLst>
              </p:nvPr>
            </p:nvGraphicFramePr>
            <p:xfrm>
              <a:off x="4505117" y="-115113"/>
              <a:ext cx="1920392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6" name="Prism 9" r:id="rId9" imgW="2376896" imgH="2828290" progId="Prism9.Document">
                      <p:embed/>
                    </p:oleObj>
                  </mc:Choice>
                  <mc:Fallback>
                    <p:oleObj name="Prism 9" r:id="rId9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4505117" y="-115113"/>
                            <a:ext cx="1920392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" name="Object 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81512979"/>
                  </p:ext>
                </p:extLst>
              </p:nvPr>
            </p:nvGraphicFramePr>
            <p:xfrm>
              <a:off x="6025028" y="-115113"/>
              <a:ext cx="2105120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7" name="Prism 9" r:id="rId11" imgW="2605582" imgH="2828290" progId="Prism9.Document">
                      <p:embed/>
                    </p:oleObj>
                  </mc:Choice>
                  <mc:Fallback>
                    <p:oleObj name="Prism 9" r:id="rId11" imgW="2605582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6025028" y="-115113"/>
                            <a:ext cx="2105120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9" name="Object 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66827050"/>
                  </p:ext>
                </p:extLst>
              </p:nvPr>
            </p:nvGraphicFramePr>
            <p:xfrm>
              <a:off x="7728851" y="-115113"/>
              <a:ext cx="1920392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8" name="Prism 9" r:id="rId13" imgW="2376896" imgH="2828290" progId="Prism9.Document">
                      <p:embed/>
                    </p:oleObj>
                  </mc:Choice>
                  <mc:Fallback>
                    <p:oleObj name="Prism 9" r:id="rId13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7728851" y="-115113"/>
                            <a:ext cx="1920392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23" name="Group 22"/>
            <p:cNvGrpSpPr/>
            <p:nvPr/>
          </p:nvGrpSpPr>
          <p:grpSpPr>
            <a:xfrm>
              <a:off x="476279" y="2153794"/>
              <a:ext cx="10032956" cy="2286000"/>
              <a:chOff x="-155488" y="2096242"/>
              <a:chExt cx="10032956" cy="2286000"/>
            </a:xfrm>
          </p:grpSpPr>
          <p:graphicFrame>
            <p:nvGraphicFramePr>
              <p:cNvPr id="10" name="Object 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960316469"/>
                  </p:ext>
                </p:extLst>
              </p:nvPr>
            </p:nvGraphicFramePr>
            <p:xfrm>
              <a:off x="-155488" y="2096242"/>
              <a:ext cx="1979405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9" name="Prism 9" r:id="rId15" imgW="2450003" imgH="2828290" progId="Prism9.Document">
                      <p:embed/>
                    </p:oleObj>
                  </mc:Choice>
                  <mc:Fallback>
                    <p:oleObj name="Prism 9" r:id="rId15" imgW="2450003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-155488" y="2096242"/>
                            <a:ext cx="1979405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1" name="Object 1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652368042"/>
                  </p:ext>
                </p:extLst>
              </p:nvPr>
            </p:nvGraphicFramePr>
            <p:xfrm>
              <a:off x="1415675" y="2096242"/>
              <a:ext cx="2105120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0" name="Prism 9" r:id="rId17" imgW="2605582" imgH="2828290" progId="Prism9.Document">
                      <p:embed/>
                    </p:oleObj>
                  </mc:Choice>
                  <mc:Fallback>
                    <p:oleObj name="Prism 9" r:id="rId17" imgW="2605582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1415675" y="2096242"/>
                            <a:ext cx="2105120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2" name="Object 1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19580634"/>
                  </p:ext>
                </p:extLst>
              </p:nvPr>
            </p:nvGraphicFramePr>
            <p:xfrm>
              <a:off x="3122827" y="2096242"/>
              <a:ext cx="1920392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1" name="Prism 9" r:id="rId19" imgW="2376896" imgH="2828290" progId="Prism9.Document">
                      <p:embed/>
                    </p:oleObj>
                  </mc:Choice>
                  <mc:Fallback>
                    <p:oleObj name="Prism 9" r:id="rId19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20"/>
                          <a:stretch>
                            <a:fillRect/>
                          </a:stretch>
                        </p:blipFill>
                        <p:spPr>
                          <a:xfrm>
                            <a:off x="3122827" y="2096242"/>
                            <a:ext cx="1920392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3" name="Object 1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48430030"/>
                  </p:ext>
                </p:extLst>
              </p:nvPr>
            </p:nvGraphicFramePr>
            <p:xfrm>
              <a:off x="4631648" y="2096242"/>
              <a:ext cx="2046113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2" name="Prism 9" r:id="rId21" imgW="2532474" imgH="2828290" progId="Prism9.Document">
                      <p:embed/>
                    </p:oleObj>
                  </mc:Choice>
                  <mc:Fallback>
                    <p:oleObj name="Prism 9" r:id="rId21" imgW="2532474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22"/>
                          <a:stretch>
                            <a:fillRect/>
                          </a:stretch>
                        </p:blipFill>
                        <p:spPr>
                          <a:xfrm>
                            <a:off x="4631648" y="2096242"/>
                            <a:ext cx="2046113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4" name="Object 1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90141129"/>
                  </p:ext>
                </p:extLst>
              </p:nvPr>
            </p:nvGraphicFramePr>
            <p:xfrm>
              <a:off x="6263521" y="2096242"/>
              <a:ext cx="2105120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3" name="Prism 9" r:id="rId23" imgW="2605582" imgH="2828290" progId="Prism9.Document">
                      <p:embed/>
                    </p:oleObj>
                  </mc:Choice>
                  <mc:Fallback>
                    <p:oleObj name="Prism 9" r:id="rId23" imgW="2605582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24"/>
                          <a:stretch>
                            <a:fillRect/>
                          </a:stretch>
                        </p:blipFill>
                        <p:spPr>
                          <a:xfrm>
                            <a:off x="6263521" y="2096242"/>
                            <a:ext cx="2105120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" name="Object 1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50623127"/>
                  </p:ext>
                </p:extLst>
              </p:nvPr>
            </p:nvGraphicFramePr>
            <p:xfrm>
              <a:off x="7898063" y="2096242"/>
              <a:ext cx="1979405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4" name="Prism 9" r:id="rId25" imgW="2450003" imgH="2828290" progId="Prism9.Document">
                      <p:embed/>
                    </p:oleObj>
                  </mc:Choice>
                  <mc:Fallback>
                    <p:oleObj name="Prism 9" r:id="rId25" imgW="2450003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26"/>
                          <a:stretch>
                            <a:fillRect/>
                          </a:stretch>
                        </p:blipFill>
                        <p:spPr>
                          <a:xfrm>
                            <a:off x="7898063" y="2096242"/>
                            <a:ext cx="1979405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24" name="Group 23"/>
            <p:cNvGrpSpPr/>
            <p:nvPr/>
          </p:nvGrpSpPr>
          <p:grpSpPr>
            <a:xfrm>
              <a:off x="492898" y="4307584"/>
              <a:ext cx="8379609" cy="2286008"/>
              <a:chOff x="-155488" y="4307584"/>
              <a:chExt cx="8379609" cy="2286008"/>
            </a:xfrm>
          </p:grpSpPr>
          <p:graphicFrame>
            <p:nvGraphicFramePr>
              <p:cNvPr id="16" name="Object 1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52588054"/>
                  </p:ext>
                </p:extLst>
              </p:nvPr>
            </p:nvGraphicFramePr>
            <p:xfrm>
              <a:off x="-155488" y="4307592"/>
              <a:ext cx="2105120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5" name="Prism 9" r:id="rId27" imgW="2605582" imgH="2828290" progId="Prism9.Document">
                      <p:embed/>
                    </p:oleObj>
                  </mc:Choice>
                  <mc:Fallback>
                    <p:oleObj name="Prism 9" r:id="rId27" imgW="2605582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28"/>
                          <a:stretch>
                            <a:fillRect/>
                          </a:stretch>
                        </p:blipFill>
                        <p:spPr>
                          <a:xfrm>
                            <a:off x="-155488" y="4307592"/>
                            <a:ext cx="2105120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8" name="Object 1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713866265"/>
                  </p:ext>
                </p:extLst>
              </p:nvPr>
            </p:nvGraphicFramePr>
            <p:xfrm>
              <a:off x="1418714" y="4307584"/>
              <a:ext cx="2046113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6" name="Prism 9" r:id="rId29" imgW="2532474" imgH="2828290" progId="Prism9.Document">
                      <p:embed/>
                    </p:oleObj>
                  </mc:Choice>
                  <mc:Fallback>
                    <p:oleObj name="Prism 9" r:id="rId29" imgW="2532474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0"/>
                          <a:stretch>
                            <a:fillRect/>
                          </a:stretch>
                        </p:blipFill>
                        <p:spPr>
                          <a:xfrm>
                            <a:off x="1418714" y="4307584"/>
                            <a:ext cx="2046113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9" name="Object 1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35189398"/>
                  </p:ext>
                </p:extLst>
              </p:nvPr>
            </p:nvGraphicFramePr>
            <p:xfrm>
              <a:off x="3113107" y="4307584"/>
              <a:ext cx="1979406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7" name="Prism 9" r:id="rId31" imgW="2450003" imgH="2828290" progId="Prism9.Document">
                      <p:embed/>
                    </p:oleObj>
                  </mc:Choice>
                  <mc:Fallback>
                    <p:oleObj name="Prism 9" r:id="rId31" imgW="2450003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2"/>
                          <a:stretch>
                            <a:fillRect/>
                          </a:stretch>
                        </p:blipFill>
                        <p:spPr>
                          <a:xfrm>
                            <a:off x="3113107" y="4307584"/>
                            <a:ext cx="1979406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0" name="Object 1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045715821"/>
                  </p:ext>
                </p:extLst>
              </p:nvPr>
            </p:nvGraphicFramePr>
            <p:xfrm>
              <a:off x="4676044" y="4307584"/>
              <a:ext cx="2046113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8" name="Prism 9" r:id="rId33" imgW="2532474" imgH="2828290" progId="Prism9.Document">
                      <p:embed/>
                    </p:oleObj>
                  </mc:Choice>
                  <mc:Fallback>
                    <p:oleObj name="Prism 9" r:id="rId33" imgW="2532474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4"/>
                          <a:stretch>
                            <a:fillRect/>
                          </a:stretch>
                        </p:blipFill>
                        <p:spPr>
                          <a:xfrm>
                            <a:off x="4676044" y="4307584"/>
                            <a:ext cx="2046113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1" name="Object 2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5328013"/>
                  </p:ext>
                </p:extLst>
              </p:nvPr>
            </p:nvGraphicFramePr>
            <p:xfrm>
              <a:off x="6303729" y="4307584"/>
              <a:ext cx="1920392" cy="228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9" name="Prism 9" r:id="rId35" imgW="2376896" imgH="2828290" progId="Prism9.Document">
                      <p:embed/>
                    </p:oleObj>
                  </mc:Choice>
                  <mc:Fallback>
                    <p:oleObj name="Prism 9" r:id="rId35" imgW="2376896" imgH="2828290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6"/>
                          <a:stretch>
                            <a:fillRect/>
                          </a:stretch>
                        </p:blipFill>
                        <p:spPr>
                          <a:xfrm>
                            <a:off x="6303729" y="4307584"/>
                            <a:ext cx="1920392" cy="228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</p:grpSp>
      <p:sp>
        <p:nvSpPr>
          <p:cNvPr id="2" name="TextBox 1"/>
          <p:cNvSpPr txBox="1"/>
          <p:nvPr/>
        </p:nvSpPr>
        <p:spPr>
          <a:xfrm>
            <a:off x="1761963" y="5910349"/>
            <a:ext cx="845558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uction of cytokines and chemokines in response to LPS. BMDM were stimulated with LPS (50 ng/ml) for 6 hours and cytokine and chemokine levels were determined using a multiplex assay. ****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≤ 0.0001, ***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≤ 0.001, **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≤ 0.01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*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≤ 0.05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18724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5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ppy, Daniel</dc:creator>
  <cp:lastModifiedBy>Shippy, Daniel</cp:lastModifiedBy>
  <cp:revision>6</cp:revision>
  <dcterms:created xsi:type="dcterms:W3CDTF">2021-08-02T16:08:45Z</dcterms:created>
  <dcterms:modified xsi:type="dcterms:W3CDTF">2021-09-08T14:51:51Z</dcterms:modified>
</cp:coreProperties>
</file>